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8" r:id="rId2"/>
    <p:sldId id="289" r:id="rId3"/>
    <p:sldId id="290" r:id="rId4"/>
  </p:sldIdLst>
  <p:sldSz cx="6372225" cy="82073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24" userDrawn="1">
          <p15:clr>
            <a:srgbClr val="A4A3A4"/>
          </p15:clr>
        </p15:guide>
        <p15:guide id="2" pos="238" userDrawn="1">
          <p15:clr>
            <a:srgbClr val="A4A3A4"/>
          </p15:clr>
        </p15:guide>
        <p15:guide id="3" pos="329" userDrawn="1">
          <p15:clr>
            <a:srgbClr val="A4A3A4"/>
          </p15:clr>
        </p15:guide>
        <p15:guide id="4" orient="horz" pos="303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339933"/>
    <a:srgbClr val="079548"/>
    <a:srgbClr val="009B4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18"/>
    <p:restoredTop sz="95263"/>
  </p:normalViewPr>
  <p:slideViewPr>
    <p:cSldViewPr snapToGrid="0" snapToObjects="1" showGuides="1">
      <p:cViewPr varScale="1">
        <p:scale>
          <a:sx n="95" d="100"/>
          <a:sy n="95" d="100"/>
        </p:scale>
        <p:origin x="2672" y="176"/>
      </p:cViewPr>
      <p:guideLst>
        <p:guide orient="horz" pos="1224"/>
        <p:guide pos="238"/>
        <p:guide pos="329"/>
        <p:guide orient="horz" pos="303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7917" y="1343199"/>
            <a:ext cx="5416391" cy="2857382"/>
          </a:xfrm>
        </p:spPr>
        <p:txBody>
          <a:bodyPr anchor="b"/>
          <a:lstStyle>
            <a:lvl1pPr algn="ctr">
              <a:defRPr sz="4181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96528" y="4310772"/>
            <a:ext cx="4779169" cy="1981549"/>
          </a:xfrm>
        </p:spPr>
        <p:txBody>
          <a:bodyPr/>
          <a:lstStyle>
            <a:lvl1pPr marL="0" indent="0" algn="ctr">
              <a:buNone/>
              <a:defRPr sz="1673"/>
            </a:lvl1pPr>
            <a:lvl2pPr marL="318623" indent="0" algn="ctr">
              <a:buNone/>
              <a:defRPr sz="1394"/>
            </a:lvl2pPr>
            <a:lvl3pPr marL="637245" indent="0" algn="ctr">
              <a:buNone/>
              <a:defRPr sz="1254"/>
            </a:lvl3pPr>
            <a:lvl4pPr marL="955868" indent="0" algn="ctr">
              <a:buNone/>
              <a:defRPr sz="1115"/>
            </a:lvl4pPr>
            <a:lvl5pPr marL="1274491" indent="0" algn="ctr">
              <a:buNone/>
              <a:defRPr sz="1115"/>
            </a:lvl5pPr>
            <a:lvl6pPr marL="1593113" indent="0" algn="ctr">
              <a:buNone/>
              <a:defRPr sz="1115"/>
            </a:lvl6pPr>
            <a:lvl7pPr marL="1911736" indent="0" algn="ctr">
              <a:buNone/>
              <a:defRPr sz="1115"/>
            </a:lvl7pPr>
            <a:lvl8pPr marL="2230359" indent="0" algn="ctr">
              <a:buNone/>
              <a:defRPr sz="1115"/>
            </a:lvl8pPr>
            <a:lvl9pPr marL="2548981" indent="0" algn="ctr">
              <a:buNone/>
              <a:defRPr sz="1115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2408955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1168238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60124" y="436967"/>
            <a:ext cx="1374011" cy="6955371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8091" y="436967"/>
            <a:ext cx="4042380" cy="6955371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1741353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2592717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772" y="2046147"/>
            <a:ext cx="5496044" cy="3414039"/>
          </a:xfrm>
        </p:spPr>
        <p:txBody>
          <a:bodyPr anchor="b"/>
          <a:lstStyle>
            <a:lvl1pPr>
              <a:defRPr sz="4181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772" y="5492484"/>
            <a:ext cx="5496044" cy="1795363"/>
          </a:xfrm>
        </p:spPr>
        <p:txBody>
          <a:bodyPr/>
          <a:lstStyle>
            <a:lvl1pPr marL="0" indent="0">
              <a:buNone/>
              <a:defRPr sz="1673">
                <a:solidFill>
                  <a:schemeClr val="tx1"/>
                </a:solidFill>
              </a:defRPr>
            </a:lvl1pPr>
            <a:lvl2pPr marL="318623" indent="0">
              <a:buNone/>
              <a:defRPr sz="1394">
                <a:solidFill>
                  <a:schemeClr val="tx1">
                    <a:tint val="75000"/>
                  </a:schemeClr>
                </a:solidFill>
              </a:defRPr>
            </a:lvl2pPr>
            <a:lvl3pPr marL="637245" indent="0">
              <a:buNone/>
              <a:defRPr sz="1254">
                <a:solidFill>
                  <a:schemeClr val="tx1">
                    <a:tint val="75000"/>
                  </a:schemeClr>
                </a:solidFill>
              </a:defRPr>
            </a:lvl3pPr>
            <a:lvl4pPr marL="955868" indent="0">
              <a:buNone/>
              <a:defRPr sz="1115">
                <a:solidFill>
                  <a:schemeClr val="tx1">
                    <a:tint val="75000"/>
                  </a:schemeClr>
                </a:solidFill>
              </a:defRPr>
            </a:lvl4pPr>
            <a:lvl5pPr marL="1274491" indent="0">
              <a:buNone/>
              <a:defRPr sz="1115">
                <a:solidFill>
                  <a:schemeClr val="tx1">
                    <a:tint val="75000"/>
                  </a:schemeClr>
                </a:solidFill>
              </a:defRPr>
            </a:lvl5pPr>
            <a:lvl6pPr marL="1593113" indent="0">
              <a:buNone/>
              <a:defRPr sz="1115">
                <a:solidFill>
                  <a:schemeClr val="tx1">
                    <a:tint val="75000"/>
                  </a:schemeClr>
                </a:solidFill>
              </a:defRPr>
            </a:lvl6pPr>
            <a:lvl7pPr marL="1911736" indent="0">
              <a:buNone/>
              <a:defRPr sz="1115">
                <a:solidFill>
                  <a:schemeClr val="tx1">
                    <a:tint val="75000"/>
                  </a:schemeClr>
                </a:solidFill>
              </a:defRPr>
            </a:lvl7pPr>
            <a:lvl8pPr marL="2230359" indent="0">
              <a:buNone/>
              <a:defRPr sz="1115">
                <a:solidFill>
                  <a:schemeClr val="tx1">
                    <a:tint val="75000"/>
                  </a:schemeClr>
                </a:solidFill>
              </a:defRPr>
            </a:lvl8pPr>
            <a:lvl9pPr marL="2548981" indent="0">
              <a:buNone/>
              <a:defRPr sz="111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108285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8090" y="2184834"/>
            <a:ext cx="2708196" cy="52075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25939" y="2184834"/>
            <a:ext cx="2708196" cy="52075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3949718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8920" y="436968"/>
            <a:ext cx="5496044" cy="158638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8921" y="2011948"/>
            <a:ext cx="2695749" cy="986024"/>
          </a:xfrm>
        </p:spPr>
        <p:txBody>
          <a:bodyPr anchor="b"/>
          <a:lstStyle>
            <a:lvl1pPr marL="0" indent="0">
              <a:buNone/>
              <a:defRPr sz="1673" b="1"/>
            </a:lvl1pPr>
            <a:lvl2pPr marL="318623" indent="0">
              <a:buNone/>
              <a:defRPr sz="1394" b="1"/>
            </a:lvl2pPr>
            <a:lvl3pPr marL="637245" indent="0">
              <a:buNone/>
              <a:defRPr sz="1254" b="1"/>
            </a:lvl3pPr>
            <a:lvl4pPr marL="955868" indent="0">
              <a:buNone/>
              <a:defRPr sz="1115" b="1"/>
            </a:lvl4pPr>
            <a:lvl5pPr marL="1274491" indent="0">
              <a:buNone/>
              <a:defRPr sz="1115" b="1"/>
            </a:lvl5pPr>
            <a:lvl6pPr marL="1593113" indent="0">
              <a:buNone/>
              <a:defRPr sz="1115" b="1"/>
            </a:lvl6pPr>
            <a:lvl7pPr marL="1911736" indent="0">
              <a:buNone/>
              <a:defRPr sz="1115" b="1"/>
            </a:lvl7pPr>
            <a:lvl8pPr marL="2230359" indent="0">
              <a:buNone/>
              <a:defRPr sz="1115" b="1"/>
            </a:lvl8pPr>
            <a:lvl9pPr marL="2548981" indent="0">
              <a:buNone/>
              <a:defRPr sz="1115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8921" y="2997972"/>
            <a:ext cx="2695749" cy="440956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25939" y="2011948"/>
            <a:ext cx="2709026" cy="986024"/>
          </a:xfrm>
        </p:spPr>
        <p:txBody>
          <a:bodyPr anchor="b"/>
          <a:lstStyle>
            <a:lvl1pPr marL="0" indent="0">
              <a:buNone/>
              <a:defRPr sz="1673" b="1"/>
            </a:lvl1pPr>
            <a:lvl2pPr marL="318623" indent="0">
              <a:buNone/>
              <a:defRPr sz="1394" b="1"/>
            </a:lvl2pPr>
            <a:lvl3pPr marL="637245" indent="0">
              <a:buNone/>
              <a:defRPr sz="1254" b="1"/>
            </a:lvl3pPr>
            <a:lvl4pPr marL="955868" indent="0">
              <a:buNone/>
              <a:defRPr sz="1115" b="1"/>
            </a:lvl4pPr>
            <a:lvl5pPr marL="1274491" indent="0">
              <a:buNone/>
              <a:defRPr sz="1115" b="1"/>
            </a:lvl5pPr>
            <a:lvl6pPr marL="1593113" indent="0">
              <a:buNone/>
              <a:defRPr sz="1115" b="1"/>
            </a:lvl6pPr>
            <a:lvl7pPr marL="1911736" indent="0">
              <a:buNone/>
              <a:defRPr sz="1115" b="1"/>
            </a:lvl7pPr>
            <a:lvl8pPr marL="2230359" indent="0">
              <a:buNone/>
              <a:defRPr sz="1115" b="1"/>
            </a:lvl8pPr>
            <a:lvl9pPr marL="2548981" indent="0">
              <a:buNone/>
              <a:defRPr sz="1115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25939" y="2997972"/>
            <a:ext cx="2709026" cy="440956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2246881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321056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1572636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8921" y="547158"/>
            <a:ext cx="2055208" cy="1915054"/>
          </a:xfrm>
        </p:spPr>
        <p:txBody>
          <a:bodyPr anchor="b"/>
          <a:lstStyle>
            <a:lvl1pPr>
              <a:defRPr sz="223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09026" y="1181712"/>
            <a:ext cx="3225939" cy="5832556"/>
          </a:xfrm>
        </p:spPr>
        <p:txBody>
          <a:bodyPr/>
          <a:lstStyle>
            <a:lvl1pPr>
              <a:defRPr sz="2230"/>
            </a:lvl1pPr>
            <a:lvl2pPr>
              <a:defRPr sz="1951"/>
            </a:lvl2pPr>
            <a:lvl3pPr>
              <a:defRPr sz="1673"/>
            </a:lvl3pPr>
            <a:lvl4pPr>
              <a:defRPr sz="1394"/>
            </a:lvl4pPr>
            <a:lvl5pPr>
              <a:defRPr sz="1394"/>
            </a:lvl5pPr>
            <a:lvl6pPr>
              <a:defRPr sz="1394"/>
            </a:lvl6pPr>
            <a:lvl7pPr>
              <a:defRPr sz="1394"/>
            </a:lvl7pPr>
            <a:lvl8pPr>
              <a:defRPr sz="1394"/>
            </a:lvl8pPr>
            <a:lvl9pPr>
              <a:defRPr sz="1394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8921" y="2462213"/>
            <a:ext cx="2055208" cy="4561553"/>
          </a:xfrm>
        </p:spPr>
        <p:txBody>
          <a:bodyPr/>
          <a:lstStyle>
            <a:lvl1pPr marL="0" indent="0">
              <a:buNone/>
              <a:defRPr sz="1115"/>
            </a:lvl1pPr>
            <a:lvl2pPr marL="318623" indent="0">
              <a:buNone/>
              <a:defRPr sz="976"/>
            </a:lvl2pPr>
            <a:lvl3pPr marL="637245" indent="0">
              <a:buNone/>
              <a:defRPr sz="836"/>
            </a:lvl3pPr>
            <a:lvl4pPr marL="955868" indent="0">
              <a:buNone/>
              <a:defRPr sz="697"/>
            </a:lvl4pPr>
            <a:lvl5pPr marL="1274491" indent="0">
              <a:buNone/>
              <a:defRPr sz="697"/>
            </a:lvl5pPr>
            <a:lvl6pPr marL="1593113" indent="0">
              <a:buNone/>
              <a:defRPr sz="697"/>
            </a:lvl6pPr>
            <a:lvl7pPr marL="1911736" indent="0">
              <a:buNone/>
              <a:defRPr sz="697"/>
            </a:lvl7pPr>
            <a:lvl8pPr marL="2230359" indent="0">
              <a:buNone/>
              <a:defRPr sz="697"/>
            </a:lvl8pPr>
            <a:lvl9pPr marL="2548981" indent="0">
              <a:buNone/>
              <a:defRPr sz="69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3752638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8921" y="547158"/>
            <a:ext cx="2055208" cy="1915054"/>
          </a:xfrm>
        </p:spPr>
        <p:txBody>
          <a:bodyPr anchor="b"/>
          <a:lstStyle>
            <a:lvl1pPr>
              <a:defRPr sz="223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09026" y="1181712"/>
            <a:ext cx="3225939" cy="5832556"/>
          </a:xfrm>
        </p:spPr>
        <p:txBody>
          <a:bodyPr anchor="t"/>
          <a:lstStyle>
            <a:lvl1pPr marL="0" indent="0">
              <a:buNone/>
              <a:defRPr sz="2230"/>
            </a:lvl1pPr>
            <a:lvl2pPr marL="318623" indent="0">
              <a:buNone/>
              <a:defRPr sz="1951"/>
            </a:lvl2pPr>
            <a:lvl3pPr marL="637245" indent="0">
              <a:buNone/>
              <a:defRPr sz="1673"/>
            </a:lvl3pPr>
            <a:lvl4pPr marL="955868" indent="0">
              <a:buNone/>
              <a:defRPr sz="1394"/>
            </a:lvl4pPr>
            <a:lvl5pPr marL="1274491" indent="0">
              <a:buNone/>
              <a:defRPr sz="1394"/>
            </a:lvl5pPr>
            <a:lvl6pPr marL="1593113" indent="0">
              <a:buNone/>
              <a:defRPr sz="1394"/>
            </a:lvl6pPr>
            <a:lvl7pPr marL="1911736" indent="0">
              <a:buNone/>
              <a:defRPr sz="1394"/>
            </a:lvl7pPr>
            <a:lvl8pPr marL="2230359" indent="0">
              <a:buNone/>
              <a:defRPr sz="1394"/>
            </a:lvl8pPr>
            <a:lvl9pPr marL="2548981" indent="0">
              <a:buNone/>
              <a:defRPr sz="1394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8921" y="2462213"/>
            <a:ext cx="2055208" cy="4561553"/>
          </a:xfrm>
        </p:spPr>
        <p:txBody>
          <a:bodyPr/>
          <a:lstStyle>
            <a:lvl1pPr marL="0" indent="0">
              <a:buNone/>
              <a:defRPr sz="1115"/>
            </a:lvl1pPr>
            <a:lvl2pPr marL="318623" indent="0">
              <a:buNone/>
              <a:defRPr sz="976"/>
            </a:lvl2pPr>
            <a:lvl3pPr marL="637245" indent="0">
              <a:buNone/>
              <a:defRPr sz="836"/>
            </a:lvl3pPr>
            <a:lvl4pPr marL="955868" indent="0">
              <a:buNone/>
              <a:defRPr sz="697"/>
            </a:lvl4pPr>
            <a:lvl5pPr marL="1274491" indent="0">
              <a:buNone/>
              <a:defRPr sz="697"/>
            </a:lvl5pPr>
            <a:lvl6pPr marL="1593113" indent="0">
              <a:buNone/>
              <a:defRPr sz="697"/>
            </a:lvl6pPr>
            <a:lvl7pPr marL="1911736" indent="0">
              <a:buNone/>
              <a:defRPr sz="697"/>
            </a:lvl7pPr>
            <a:lvl8pPr marL="2230359" indent="0">
              <a:buNone/>
              <a:defRPr sz="697"/>
            </a:lvl8pPr>
            <a:lvl9pPr marL="2548981" indent="0">
              <a:buNone/>
              <a:defRPr sz="69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W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2049268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8091" y="436968"/>
            <a:ext cx="5496044" cy="15863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8091" y="2184834"/>
            <a:ext cx="5496044" cy="5207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8090" y="7607022"/>
            <a:ext cx="1433751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8B812-2899-9A46-B690-C1AC18CD9554}" type="datetimeFigureOut">
              <a:rPr lang="en-TW" smtClean="0"/>
              <a:t>2022/5/30</a:t>
            </a:fld>
            <a:endParaRPr lang="en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10800" y="7607022"/>
            <a:ext cx="2150626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W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00384" y="7607022"/>
            <a:ext cx="1433751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5734E-7855-6B42-81A6-4B14EFD4E3E7}" type="slidenum">
              <a:rPr lang="en-TW" smtClean="0"/>
              <a:t>‹#›</a:t>
            </a:fld>
            <a:endParaRPr lang="en-TW"/>
          </a:p>
        </p:txBody>
      </p:sp>
    </p:spTree>
    <p:extLst>
      <p:ext uri="{BB962C8B-B14F-4D97-AF65-F5344CB8AC3E}">
        <p14:creationId xmlns:p14="http://schemas.microsoft.com/office/powerpoint/2010/main" val="3187882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37245" rtl="0" eaLnBrk="1" latinLnBrk="0" hangingPunct="1">
        <a:lnSpc>
          <a:spcPct val="90000"/>
        </a:lnSpc>
        <a:spcBef>
          <a:spcPct val="0"/>
        </a:spcBef>
        <a:buNone/>
        <a:defRPr sz="306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9311" indent="-159311" algn="l" defTabSz="637245" rtl="0" eaLnBrk="1" latinLnBrk="0" hangingPunct="1">
        <a:lnSpc>
          <a:spcPct val="90000"/>
        </a:lnSpc>
        <a:spcBef>
          <a:spcPts val="697"/>
        </a:spcBef>
        <a:buFont typeface="Arial" panose="020B0604020202020204" pitchFamily="34" charset="0"/>
        <a:buChar char="•"/>
        <a:defRPr sz="1951" kern="1200">
          <a:solidFill>
            <a:schemeClr val="tx1"/>
          </a:solidFill>
          <a:latin typeface="+mn-lt"/>
          <a:ea typeface="+mn-ea"/>
          <a:cs typeface="+mn-cs"/>
        </a:defRPr>
      </a:lvl1pPr>
      <a:lvl2pPr marL="477934" indent="-159311" algn="l" defTabSz="637245" rtl="0" eaLnBrk="1" latinLnBrk="0" hangingPunct="1">
        <a:lnSpc>
          <a:spcPct val="90000"/>
        </a:lnSpc>
        <a:spcBef>
          <a:spcPts val="348"/>
        </a:spcBef>
        <a:buFont typeface="Arial" panose="020B0604020202020204" pitchFamily="34" charset="0"/>
        <a:buChar char="•"/>
        <a:defRPr sz="1673" kern="1200">
          <a:solidFill>
            <a:schemeClr val="tx1"/>
          </a:solidFill>
          <a:latin typeface="+mn-lt"/>
          <a:ea typeface="+mn-ea"/>
          <a:cs typeface="+mn-cs"/>
        </a:defRPr>
      </a:lvl2pPr>
      <a:lvl3pPr marL="796557" indent="-159311" algn="l" defTabSz="637245" rtl="0" eaLnBrk="1" latinLnBrk="0" hangingPunct="1">
        <a:lnSpc>
          <a:spcPct val="90000"/>
        </a:lnSpc>
        <a:spcBef>
          <a:spcPts val="348"/>
        </a:spcBef>
        <a:buFont typeface="Arial" panose="020B0604020202020204" pitchFamily="34" charset="0"/>
        <a:buChar char="•"/>
        <a:defRPr sz="1394" kern="1200">
          <a:solidFill>
            <a:schemeClr val="tx1"/>
          </a:solidFill>
          <a:latin typeface="+mn-lt"/>
          <a:ea typeface="+mn-ea"/>
          <a:cs typeface="+mn-cs"/>
        </a:defRPr>
      </a:lvl3pPr>
      <a:lvl4pPr marL="1115179" indent="-159311" algn="l" defTabSz="637245" rtl="0" eaLnBrk="1" latinLnBrk="0" hangingPunct="1">
        <a:lnSpc>
          <a:spcPct val="90000"/>
        </a:lnSpc>
        <a:spcBef>
          <a:spcPts val="348"/>
        </a:spcBef>
        <a:buFont typeface="Arial" panose="020B0604020202020204" pitchFamily="34" charset="0"/>
        <a:buChar char="•"/>
        <a:defRPr sz="1254" kern="1200">
          <a:solidFill>
            <a:schemeClr val="tx1"/>
          </a:solidFill>
          <a:latin typeface="+mn-lt"/>
          <a:ea typeface="+mn-ea"/>
          <a:cs typeface="+mn-cs"/>
        </a:defRPr>
      </a:lvl4pPr>
      <a:lvl5pPr marL="1433802" indent="-159311" algn="l" defTabSz="637245" rtl="0" eaLnBrk="1" latinLnBrk="0" hangingPunct="1">
        <a:lnSpc>
          <a:spcPct val="90000"/>
        </a:lnSpc>
        <a:spcBef>
          <a:spcPts val="348"/>
        </a:spcBef>
        <a:buFont typeface="Arial" panose="020B0604020202020204" pitchFamily="34" charset="0"/>
        <a:buChar char="•"/>
        <a:defRPr sz="1254" kern="1200">
          <a:solidFill>
            <a:schemeClr val="tx1"/>
          </a:solidFill>
          <a:latin typeface="+mn-lt"/>
          <a:ea typeface="+mn-ea"/>
          <a:cs typeface="+mn-cs"/>
        </a:defRPr>
      </a:lvl5pPr>
      <a:lvl6pPr marL="1752425" indent="-159311" algn="l" defTabSz="637245" rtl="0" eaLnBrk="1" latinLnBrk="0" hangingPunct="1">
        <a:lnSpc>
          <a:spcPct val="90000"/>
        </a:lnSpc>
        <a:spcBef>
          <a:spcPts val="348"/>
        </a:spcBef>
        <a:buFont typeface="Arial" panose="020B0604020202020204" pitchFamily="34" charset="0"/>
        <a:buChar char="•"/>
        <a:defRPr sz="1254" kern="1200">
          <a:solidFill>
            <a:schemeClr val="tx1"/>
          </a:solidFill>
          <a:latin typeface="+mn-lt"/>
          <a:ea typeface="+mn-ea"/>
          <a:cs typeface="+mn-cs"/>
        </a:defRPr>
      </a:lvl6pPr>
      <a:lvl7pPr marL="2071047" indent="-159311" algn="l" defTabSz="637245" rtl="0" eaLnBrk="1" latinLnBrk="0" hangingPunct="1">
        <a:lnSpc>
          <a:spcPct val="90000"/>
        </a:lnSpc>
        <a:spcBef>
          <a:spcPts val="348"/>
        </a:spcBef>
        <a:buFont typeface="Arial" panose="020B0604020202020204" pitchFamily="34" charset="0"/>
        <a:buChar char="•"/>
        <a:defRPr sz="1254" kern="1200">
          <a:solidFill>
            <a:schemeClr val="tx1"/>
          </a:solidFill>
          <a:latin typeface="+mn-lt"/>
          <a:ea typeface="+mn-ea"/>
          <a:cs typeface="+mn-cs"/>
        </a:defRPr>
      </a:lvl7pPr>
      <a:lvl8pPr marL="2389670" indent="-159311" algn="l" defTabSz="637245" rtl="0" eaLnBrk="1" latinLnBrk="0" hangingPunct="1">
        <a:lnSpc>
          <a:spcPct val="90000"/>
        </a:lnSpc>
        <a:spcBef>
          <a:spcPts val="348"/>
        </a:spcBef>
        <a:buFont typeface="Arial" panose="020B0604020202020204" pitchFamily="34" charset="0"/>
        <a:buChar char="•"/>
        <a:defRPr sz="1254" kern="1200">
          <a:solidFill>
            <a:schemeClr val="tx1"/>
          </a:solidFill>
          <a:latin typeface="+mn-lt"/>
          <a:ea typeface="+mn-ea"/>
          <a:cs typeface="+mn-cs"/>
        </a:defRPr>
      </a:lvl8pPr>
      <a:lvl9pPr marL="2708293" indent="-159311" algn="l" defTabSz="637245" rtl="0" eaLnBrk="1" latinLnBrk="0" hangingPunct="1">
        <a:lnSpc>
          <a:spcPct val="90000"/>
        </a:lnSpc>
        <a:spcBef>
          <a:spcPts val="348"/>
        </a:spcBef>
        <a:buFont typeface="Arial" panose="020B0604020202020204" pitchFamily="34" charset="0"/>
        <a:buChar char="•"/>
        <a:defRPr sz="125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1pPr>
      <a:lvl2pPr marL="318623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2pPr>
      <a:lvl3pPr marL="637245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3pPr>
      <a:lvl4pPr marL="955868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4pPr>
      <a:lvl5pPr marL="1274491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5pPr>
      <a:lvl6pPr marL="1593113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6pPr>
      <a:lvl7pPr marL="1911736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7pPr>
      <a:lvl8pPr marL="2230359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8pPr>
      <a:lvl9pPr marL="2548981" algn="l" defTabSz="637245" rtl="0" eaLnBrk="1" latinLnBrk="0" hangingPunct="1">
        <a:defRPr sz="125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4">
            <a:extLst>
              <a:ext uri="{FF2B5EF4-FFF2-40B4-BE49-F238E27FC236}">
                <a16:creationId xmlns:a16="http://schemas.microsoft.com/office/drawing/2014/main" id="{5A9CD64D-91F4-EA31-8F26-C6B0BBFD36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1268687"/>
              </p:ext>
            </p:extLst>
          </p:nvPr>
        </p:nvGraphicFramePr>
        <p:xfrm>
          <a:off x="263311" y="970561"/>
          <a:ext cx="5845601" cy="4389695"/>
        </p:xfrm>
        <a:graphic>
          <a:graphicData uri="http://schemas.openxmlformats.org/drawingml/2006/table">
            <a:tbl>
              <a:tblPr/>
              <a:tblGrid>
                <a:gridCol w="2828713">
                  <a:extLst>
                    <a:ext uri="{9D8B030D-6E8A-4147-A177-3AD203B41FA5}">
                      <a16:colId xmlns:a16="http://schemas.microsoft.com/office/drawing/2014/main" val="3680117901"/>
                    </a:ext>
                  </a:extLst>
                </a:gridCol>
                <a:gridCol w="293475">
                  <a:extLst>
                    <a:ext uri="{9D8B030D-6E8A-4147-A177-3AD203B41FA5}">
                      <a16:colId xmlns:a16="http://schemas.microsoft.com/office/drawing/2014/main" val="3959901968"/>
                    </a:ext>
                  </a:extLst>
                </a:gridCol>
                <a:gridCol w="622088">
                  <a:extLst>
                    <a:ext uri="{9D8B030D-6E8A-4147-A177-3AD203B41FA5}">
                      <a16:colId xmlns:a16="http://schemas.microsoft.com/office/drawing/2014/main" val="1647572841"/>
                    </a:ext>
                  </a:extLst>
                </a:gridCol>
                <a:gridCol w="622088">
                  <a:extLst>
                    <a:ext uri="{9D8B030D-6E8A-4147-A177-3AD203B41FA5}">
                      <a16:colId xmlns:a16="http://schemas.microsoft.com/office/drawing/2014/main" val="2472319592"/>
                    </a:ext>
                  </a:extLst>
                </a:gridCol>
                <a:gridCol w="704003">
                  <a:extLst>
                    <a:ext uri="{9D8B030D-6E8A-4147-A177-3AD203B41FA5}">
                      <a16:colId xmlns:a16="http://schemas.microsoft.com/office/drawing/2014/main" val="3028076619"/>
                    </a:ext>
                  </a:extLst>
                </a:gridCol>
                <a:gridCol w="775234">
                  <a:extLst>
                    <a:ext uri="{9D8B030D-6E8A-4147-A177-3AD203B41FA5}">
                      <a16:colId xmlns:a16="http://schemas.microsoft.com/office/drawing/2014/main" val="709445035"/>
                    </a:ext>
                  </a:extLst>
                </a:gridCol>
              </a:tblGrid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AME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IZE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ES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ES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OM p-val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FDR q-val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5710782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EPITHELIAL_MESENCHYMAL_</a:t>
                      </a:r>
                    </a:p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TRANSITION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610382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.029342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9368501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UV_RESPONSE_DN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4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1438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957569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575404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APICAL_JUNCTION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8589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7358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643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1370420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MITOTIC_SPINDLE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8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75255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59513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232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2309987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COMPLEMENT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5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6847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22839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797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8769322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ALLOGRAFT_REJECTION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9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4710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2121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349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0211863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MYOGENESIS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9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42233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84321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83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1248358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INFLAMMATORY_RESPONSE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7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3812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83638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22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1655373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COAGULATION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3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520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58685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57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1570649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ANGIOGENESIS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2199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524527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508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4439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1274747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KRAS_SIGNALING_UP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0172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483935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751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8687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3687936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HEDGEHOG_SIGNALING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5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05841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478607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5161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817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2348224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TGF_BETA_SIGNALING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5914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444546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3013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3141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1094832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IL6_JAK_STAT3_SIGNALING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7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2384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396658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336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397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0263025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IL2_STAT5_SIGNALING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5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280485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382465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662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602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4399954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G2M_CHECKPOINT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4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273148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353981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751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5069</a:t>
                      </a:r>
                    </a:p>
                  </a:txBody>
                  <a:tcPr marL="2275" marR="2275" marT="22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1524246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OXIDATIVE_PHOSPHORYL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82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7675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0895434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FATTY_ACID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5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95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302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1857086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PEROXISO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0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388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922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796832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MYC_TARGETS_V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82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900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6355123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ADIPOGENESI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959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8953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8726207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GLYCOLYSI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630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748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75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9207682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CHOLESTEROL_HOMEOSTASI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13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6979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53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8312674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MYC_TARGETS_V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482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6716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23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0415696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BILE_ACID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695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632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7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612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592484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DNA_REPAI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516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6167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76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66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8091522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XENOBIOTIC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21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5447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229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6673617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P53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027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454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87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870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1626012"/>
                  </a:ext>
                </a:extLst>
              </a:tr>
              <a:tr h="1325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ALLMARK_INTERFERON_ALPHA_RESPONS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28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39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255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60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5054735"/>
                  </a:ext>
                </a:extLst>
              </a:tr>
            </a:tbl>
          </a:graphicData>
        </a:graphic>
      </p:graphicFrame>
      <p:sp>
        <p:nvSpPr>
          <p:cNvPr id="3" name="文字方塊 5">
            <a:extLst>
              <a:ext uri="{FF2B5EF4-FFF2-40B4-BE49-F238E27FC236}">
                <a16:creationId xmlns:a16="http://schemas.microsoft.com/office/drawing/2014/main" id="{D24199E2-10B4-51BE-8766-379902D08FB8}"/>
              </a:ext>
            </a:extLst>
          </p:cNvPr>
          <p:cNvSpPr txBox="1"/>
          <p:nvPr/>
        </p:nvSpPr>
        <p:spPr>
          <a:xfrm>
            <a:off x="131976" y="447341"/>
            <a:ext cx="60299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Hallmarks enriched in </a:t>
            </a:r>
            <a:r>
              <a:rPr kumimoji="0" lang="en-US" altLang="zh-TW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Oxaliplatin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containing therapy-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Non response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or 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response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TCGA CRC patients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373F6CF-DB9E-B685-36AA-E6DD164E4D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8949834"/>
              </p:ext>
            </p:extLst>
          </p:nvPr>
        </p:nvGraphicFramePr>
        <p:xfrm>
          <a:off x="263312" y="5883655"/>
          <a:ext cx="5845600" cy="2213417"/>
        </p:xfrm>
        <a:graphic>
          <a:graphicData uri="http://schemas.openxmlformats.org/drawingml/2006/table">
            <a:tbl>
              <a:tblPr/>
              <a:tblGrid>
                <a:gridCol w="2690715">
                  <a:extLst>
                    <a:ext uri="{9D8B030D-6E8A-4147-A177-3AD203B41FA5}">
                      <a16:colId xmlns:a16="http://schemas.microsoft.com/office/drawing/2014/main" val="2392792141"/>
                    </a:ext>
                  </a:extLst>
                </a:gridCol>
                <a:gridCol w="630977">
                  <a:extLst>
                    <a:ext uri="{9D8B030D-6E8A-4147-A177-3AD203B41FA5}">
                      <a16:colId xmlns:a16="http://schemas.microsoft.com/office/drawing/2014/main" val="1267412745"/>
                    </a:ext>
                  </a:extLst>
                </a:gridCol>
                <a:gridCol w="630977">
                  <a:extLst>
                    <a:ext uri="{9D8B030D-6E8A-4147-A177-3AD203B41FA5}">
                      <a16:colId xmlns:a16="http://schemas.microsoft.com/office/drawing/2014/main" val="534559449"/>
                    </a:ext>
                  </a:extLst>
                </a:gridCol>
                <a:gridCol w="630977">
                  <a:extLst>
                    <a:ext uri="{9D8B030D-6E8A-4147-A177-3AD203B41FA5}">
                      <a16:colId xmlns:a16="http://schemas.microsoft.com/office/drawing/2014/main" val="4204081437"/>
                    </a:ext>
                  </a:extLst>
                </a:gridCol>
                <a:gridCol w="630977">
                  <a:extLst>
                    <a:ext uri="{9D8B030D-6E8A-4147-A177-3AD203B41FA5}">
                      <a16:colId xmlns:a16="http://schemas.microsoft.com/office/drawing/2014/main" val="832113950"/>
                    </a:ext>
                  </a:extLst>
                </a:gridCol>
                <a:gridCol w="630977">
                  <a:extLst>
                    <a:ext uri="{9D8B030D-6E8A-4147-A177-3AD203B41FA5}">
                      <a16:colId xmlns:a16="http://schemas.microsoft.com/office/drawing/2014/main" val="3633775872"/>
                    </a:ext>
                  </a:extLst>
                </a:gridCol>
              </a:tblGrid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M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Z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M p-va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 q-va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878411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MITOTIC_SPINDL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9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475398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.34049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777315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G2M_CHECKPOIN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9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4634394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.27503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5648325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UV_RESPONSE_D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395547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831615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054468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108131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ANDROGEN_RESPONS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377508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66226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15344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8559827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E2F_TARGET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3356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63569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159763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9723023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INFLAMMATORY_RESPONS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5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334707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578862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25427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5802534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ESTROGEN_RESPONSE_EARL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9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3235877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57148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246119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0968083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TGF_BETA_SIGNALIN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5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4465032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774872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0190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06342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454447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IL2_STAT5_SIGNALIN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7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29673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441219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1198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794357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2143886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APICAL_JUNC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284951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373581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257289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109429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9753456"/>
                  </a:ext>
                </a:extLst>
              </a:tr>
              <a:tr h="28757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HALLMARK_EPITHELIAL_MESENCHYMAL_</a:t>
                      </a:r>
                    </a:p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TRANSI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7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264733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27596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477815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1942113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4506062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HALLMARK_OXIDATIVE_PHOSPHORYL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1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-0.49110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-2.496211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0511642"/>
                  </a:ext>
                </a:extLst>
              </a:tr>
              <a:tr h="1481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HALLMARK_DNA_REPAI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14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-0.303821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-1.472601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0.009367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Calibri" panose="020F0502020204030204" pitchFamily="34" charset="0"/>
                        </a:rPr>
                        <a:t>0.0769669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776852"/>
                  </a:ext>
                </a:extLst>
              </a:tr>
            </a:tbl>
          </a:graphicData>
        </a:graphic>
      </p:graphicFrame>
      <p:sp>
        <p:nvSpPr>
          <p:cNvPr id="5" name="矩形 11">
            <a:extLst>
              <a:ext uri="{FF2B5EF4-FFF2-40B4-BE49-F238E27FC236}">
                <a16:creationId xmlns:a16="http://schemas.microsoft.com/office/drawing/2014/main" id="{3AD2FEB1-F635-F554-78A7-42B6B13DE014}"/>
              </a:ext>
            </a:extLst>
          </p:cNvPr>
          <p:cNvSpPr/>
          <p:nvPr/>
        </p:nvSpPr>
        <p:spPr>
          <a:xfrm>
            <a:off x="224147" y="5468067"/>
            <a:ext cx="584560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Hallmarks enriched in Oxaliplatin-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resistant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or 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srgbClr val="0000CC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sensitive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CRC PDOs</a:t>
            </a:r>
            <a:endParaRPr kumimoji="0" lang="zh-TW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文字方塊 54">
            <a:extLst>
              <a:ext uri="{FF2B5EF4-FFF2-40B4-BE49-F238E27FC236}">
                <a16:creationId xmlns:a16="http://schemas.microsoft.com/office/drawing/2014/main" id="{4FC4302A-4B0E-08B9-13BA-E550E024B32F}"/>
              </a:ext>
            </a:extLst>
          </p:cNvPr>
          <p:cNvSpPr txBox="1"/>
          <p:nvPr/>
        </p:nvSpPr>
        <p:spPr>
          <a:xfrm>
            <a:off x="0" y="-11112"/>
            <a:ext cx="29817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85006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8">
            <a:extLst>
              <a:ext uri="{FF2B5EF4-FFF2-40B4-BE49-F238E27FC236}">
                <a16:creationId xmlns:a16="http://schemas.microsoft.com/office/drawing/2014/main" id="{D4BB27E5-E948-C6C1-93E6-03F342C21B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2396229"/>
              </p:ext>
            </p:extLst>
          </p:nvPr>
        </p:nvGraphicFramePr>
        <p:xfrm>
          <a:off x="343073" y="655603"/>
          <a:ext cx="5686078" cy="6838499"/>
        </p:xfrm>
        <a:graphic>
          <a:graphicData uri="http://schemas.openxmlformats.org/drawingml/2006/table">
            <a:tbl>
              <a:tblPr/>
              <a:tblGrid>
                <a:gridCol w="3404446">
                  <a:extLst>
                    <a:ext uri="{9D8B030D-6E8A-4147-A177-3AD203B41FA5}">
                      <a16:colId xmlns:a16="http://schemas.microsoft.com/office/drawing/2014/main" val="99360789"/>
                    </a:ext>
                  </a:extLst>
                </a:gridCol>
                <a:gridCol w="223877">
                  <a:extLst>
                    <a:ext uri="{9D8B030D-6E8A-4147-A177-3AD203B41FA5}">
                      <a16:colId xmlns:a16="http://schemas.microsoft.com/office/drawing/2014/main" val="856773623"/>
                    </a:ext>
                  </a:extLst>
                </a:gridCol>
                <a:gridCol w="466792">
                  <a:extLst>
                    <a:ext uri="{9D8B030D-6E8A-4147-A177-3AD203B41FA5}">
                      <a16:colId xmlns:a16="http://schemas.microsoft.com/office/drawing/2014/main" val="1714413570"/>
                    </a:ext>
                  </a:extLst>
                </a:gridCol>
                <a:gridCol w="466792">
                  <a:extLst>
                    <a:ext uri="{9D8B030D-6E8A-4147-A177-3AD203B41FA5}">
                      <a16:colId xmlns:a16="http://schemas.microsoft.com/office/drawing/2014/main" val="160977743"/>
                    </a:ext>
                  </a:extLst>
                </a:gridCol>
                <a:gridCol w="541286">
                  <a:extLst>
                    <a:ext uri="{9D8B030D-6E8A-4147-A177-3AD203B41FA5}">
                      <a16:colId xmlns:a16="http://schemas.microsoft.com/office/drawing/2014/main" val="2718541592"/>
                    </a:ext>
                  </a:extLst>
                </a:gridCol>
                <a:gridCol w="582885">
                  <a:extLst>
                    <a:ext uri="{9D8B030D-6E8A-4147-A177-3AD203B41FA5}">
                      <a16:colId xmlns:a16="http://schemas.microsoft.com/office/drawing/2014/main" val="4182770733"/>
                    </a:ext>
                  </a:extLst>
                </a:gridCol>
              </a:tblGrid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AME_TCGA CRC patients (</a:t>
                      </a:r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on response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vs </a:t>
                      </a:r>
                      <a:r>
                        <a:rPr lang="en-US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respons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)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IZE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ES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ES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OM p-val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FDR q-val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9019251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ECM_RECEPTOR_INTERACTION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9869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578771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0251235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FOCAL_ADHESION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7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7524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33727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627235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CELL_ADHESION_MOLECULES_CAMS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28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44776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06687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701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2645413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GLYCOSAMINOGLYCAN_BIOSYNTHESIS_CHONDROITIN_SULFATE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622428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018204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488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5052784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XON_GUIDANCE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27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9963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75939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392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0658153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VIRAL_MYOCARDITIS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8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43508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43258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2227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4439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9762410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UTOIMMUNE_THYROID_DISEASE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6077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86819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213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1578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3799969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REGULATION_OF_ACTIN_CYTOSKELETON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1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5652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6705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2864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1375025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LEUKOCYTE_TRANSENDOTHELIAL_MIGRATION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1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8043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2333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289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7184860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DILATED_CARDIOMYOPATHY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9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91031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15767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1796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9568453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HEMATOPOIETIC_CELL_LINEAGE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4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8843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88011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6547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7358584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HEDGEHOG_SIGNALING_PATHWAY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6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1196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519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216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555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5944059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CHEMOKINE_SIGNALING_PATHWAY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8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3412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45596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434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0348201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NTIGEN_PROCESSING_AND_PRESENTATION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0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80474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2266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386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50349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1919107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TYPE_I_DIABETES_MELLITUS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1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40831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19277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976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828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2475410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HYPERTROPHIC_CARDIOMYOPATHY_HCM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70224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09471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4237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927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1353672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STHMA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8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6723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06062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919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7923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8943080"/>
                  </a:ext>
                </a:extLst>
              </a:tr>
              <a:tr h="124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LLOGRAFT_REJECTION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48576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04771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3304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5755</a:t>
                      </a:r>
                    </a:p>
                  </a:txBody>
                  <a:tcPr marL="1781" marR="1781" marT="178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1974111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VALINE_LEUCINE_AND_ISOLEUCINE_DEGRAD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727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6828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3375082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EROXISO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630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618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086575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BUTANOAT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7418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5938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6714142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RIBOSO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6145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568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0581853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FATTY_ACID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6427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342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1992607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ARKINSONS_DISEAS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9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03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192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45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3592213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OXIDATIVE_PHOSPHORYL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00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181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24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0773792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ROPANOAT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6283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1644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09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745480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YRUVAT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948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14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9.68E-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2317056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LYSINE_DEGRAD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789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093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4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0867586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GLYCOLYSIS_GLUCONEOGENESI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28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0672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50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4485478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ENTOSE_PHOSPHATE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6277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067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29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9434569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RGININE_AND_PROLIN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364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054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11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776283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TRYPTOPHAN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5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9954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41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6075950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TERPENOID_BACKBONE_BIOSYNTHESI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685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922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9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54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5909803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HUNTINGTONS_DISEAS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6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092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9185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5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2872884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BETA_ALANIN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914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878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88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208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762436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SCORBATE_AND_ALDARAT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898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8726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22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5611032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STARCH_AND_SUCROS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846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8217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8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0123241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CITRATE_CYCLE_TCA_CYCL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315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819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80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1274500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BIOSYNTHESIS_OF_UNSATURATED_FATTY_ACID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685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7878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79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59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1619874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LZHEIMERS_DISEAS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4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895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775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65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2945887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FRUCTOSE_AND_MANNOS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64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6426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35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57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1507830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ORPHYRIN_AND_CHLOROPHYLL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44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6306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8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757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091573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GLYOXYLATE_AND_DICARBOXYLAT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572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614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636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055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7188117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MATURITY_ONSET_DIABETES_OF_THE_YOUNG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928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583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18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884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4069752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MYOTROPHIC_LATERAL_SCLEROSIS_AL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23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5702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69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15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9840353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CYSTEINE_AND_METHIONIN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390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5598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50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359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0964081"/>
                  </a:ext>
                </a:extLst>
              </a:tr>
              <a:tr h="12960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RETINOL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3877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549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06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60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2720251"/>
                  </a:ext>
                </a:extLst>
              </a:tr>
            </a:tbl>
          </a:graphicData>
        </a:graphic>
      </p:graphicFrame>
      <p:sp>
        <p:nvSpPr>
          <p:cNvPr id="3" name="文字方塊 5">
            <a:extLst>
              <a:ext uri="{FF2B5EF4-FFF2-40B4-BE49-F238E27FC236}">
                <a16:creationId xmlns:a16="http://schemas.microsoft.com/office/drawing/2014/main" id="{D19C7F6B-79A0-2F07-618F-D5E8324C7E08}"/>
              </a:ext>
            </a:extLst>
          </p:cNvPr>
          <p:cNvSpPr txBox="1"/>
          <p:nvPr/>
        </p:nvSpPr>
        <p:spPr>
          <a:xfrm>
            <a:off x="171140" y="85624"/>
            <a:ext cx="60299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sz="1400" b="1" dirty="0">
                <a:solidFill>
                  <a:prstClr val="black"/>
                </a:solidFill>
                <a:latin typeface="Calibri" panose="020F0502020204030204"/>
                <a:ea typeface="新細明體" panose="02020500000000000000" pitchFamily="18" charset="-120"/>
              </a:rPr>
              <a:t>Pathways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enriched in Oxaliplatin containing therapy-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Non response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or 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response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TCGA CRC patients</a:t>
            </a:r>
          </a:p>
        </p:txBody>
      </p:sp>
    </p:spTree>
    <p:extLst>
      <p:ext uri="{BB962C8B-B14F-4D97-AF65-F5344CB8AC3E}">
        <p14:creationId xmlns:p14="http://schemas.microsoft.com/office/powerpoint/2010/main" val="13646068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2">
            <a:extLst>
              <a:ext uri="{FF2B5EF4-FFF2-40B4-BE49-F238E27FC236}">
                <a16:creationId xmlns:a16="http://schemas.microsoft.com/office/drawing/2014/main" id="{EF0AFCBD-E3F4-E9E7-951E-8AD0695ACA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7484819"/>
              </p:ext>
            </p:extLst>
          </p:nvPr>
        </p:nvGraphicFramePr>
        <p:xfrm>
          <a:off x="412124" y="493931"/>
          <a:ext cx="5547976" cy="6238318"/>
        </p:xfrm>
        <a:graphic>
          <a:graphicData uri="http://schemas.openxmlformats.org/drawingml/2006/table">
            <a:tbl>
              <a:tblPr/>
              <a:tblGrid>
                <a:gridCol w="3128328">
                  <a:extLst>
                    <a:ext uri="{9D8B030D-6E8A-4147-A177-3AD203B41FA5}">
                      <a16:colId xmlns:a16="http://schemas.microsoft.com/office/drawing/2014/main" val="3643191727"/>
                    </a:ext>
                  </a:extLst>
                </a:gridCol>
                <a:gridCol w="241607">
                  <a:extLst>
                    <a:ext uri="{9D8B030D-6E8A-4147-A177-3AD203B41FA5}">
                      <a16:colId xmlns:a16="http://schemas.microsoft.com/office/drawing/2014/main" val="1939405963"/>
                    </a:ext>
                  </a:extLst>
                </a:gridCol>
                <a:gridCol w="531178">
                  <a:extLst>
                    <a:ext uri="{9D8B030D-6E8A-4147-A177-3AD203B41FA5}">
                      <a16:colId xmlns:a16="http://schemas.microsoft.com/office/drawing/2014/main" val="1903979404"/>
                    </a:ext>
                  </a:extLst>
                </a:gridCol>
                <a:gridCol w="531178">
                  <a:extLst>
                    <a:ext uri="{9D8B030D-6E8A-4147-A177-3AD203B41FA5}">
                      <a16:colId xmlns:a16="http://schemas.microsoft.com/office/drawing/2014/main" val="2105674369"/>
                    </a:ext>
                  </a:extLst>
                </a:gridCol>
                <a:gridCol w="584507">
                  <a:extLst>
                    <a:ext uri="{9D8B030D-6E8A-4147-A177-3AD203B41FA5}">
                      <a16:colId xmlns:a16="http://schemas.microsoft.com/office/drawing/2014/main" val="1380354050"/>
                    </a:ext>
                  </a:extLst>
                </a:gridCol>
                <a:gridCol w="531178">
                  <a:extLst>
                    <a:ext uri="{9D8B030D-6E8A-4147-A177-3AD203B41FA5}">
                      <a16:colId xmlns:a16="http://schemas.microsoft.com/office/drawing/2014/main" val="1732258079"/>
                    </a:ext>
                  </a:extLst>
                </a:gridCol>
              </a:tblGrid>
              <a:tr h="1391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AME</a:t>
                      </a:r>
                    </a:p>
                  </a:txBody>
                  <a:tcPr marL="947" marR="947" marT="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IZE</a:t>
                      </a:r>
                    </a:p>
                  </a:txBody>
                  <a:tcPr marL="947" marR="947" marT="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ES</a:t>
                      </a:r>
                    </a:p>
                  </a:txBody>
                  <a:tcPr marL="947" marR="947" marT="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ES</a:t>
                      </a:r>
                    </a:p>
                  </a:txBody>
                  <a:tcPr marL="947" marR="947" marT="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NOM p-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val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47" marR="947" marT="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FDR q-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val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47" marR="947" marT="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9303139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CHRONIC_MYELOID_LEUKEMIA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225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19177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6043632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NON_SMALL_CELL_LUNG_CANC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479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.0786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2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6370807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SMALL_CELL_LUNG_CANC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662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9902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960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7136445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BASAL_CELL_CARCINOMA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2979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9889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720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9059505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ENDOMETRIAL_CANC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056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9881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602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3511997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GAP_JUNC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7146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9678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616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3312670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ROSTATE_CANC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5709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9565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645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6613127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ERBB_SIGNALING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437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91436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977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8750729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GLIOMA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714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809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8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44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4110457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SPHINGOLIPID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321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7578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34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6193338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MELANOGENESI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3129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401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735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1690737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ECM_RECEPTOR_INTERAC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5144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249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86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549821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ATHWAYS_IN_CANC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8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5016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8001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15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9597365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LYSINE_DEGRAD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9304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966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08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6467058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RENAL_CELL_CARCINOMA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423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9316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0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318789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FOCAL_ADHES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6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759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849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025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210508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ANCREATIC_CANC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318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8015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028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777588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REGULATION_OF_ACTIN_CYTOSKELET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675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743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006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6146397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TGF_BETA_SIGNALING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2397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725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77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94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8044916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GLYCOSAMINOGLYCAN_BIOSYNTHESIS_HEPARAN_SULFAT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474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5873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77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083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3459479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MELANOMA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3117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27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6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65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279053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NEUROTROPHIN_SIGNALING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769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2014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693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3390479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HEDGEHOG_SIGNALING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6224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70657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543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90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2653755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T_CELL_RECEPTOR_SIGNALING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9767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9744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97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995329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INOSITOL_PHOSPHATE_METABOLIS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3463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930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55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980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9926043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DHERENS_JUNC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092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907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894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902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5166035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CUTE_MYELOID_LEUKEMIA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3504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863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6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291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9732369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POPTOSI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9209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6602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79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24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410722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WNT_SIGNALING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624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630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7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166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953849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LEISHMANIA_INFEC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4152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5832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36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197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6017836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INSULIN_SIGNALING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2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600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455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526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50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5412151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ENTOSE_PHOSPHATE_PATHWA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0956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3854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100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3577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159060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DORSO_VENTRAL_AXIS_FORM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5016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1725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15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135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9455618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XON_GUIDANC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588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6083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3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4763445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HOSPHATIDYLINOSITOL_SIGNALING_SYSTE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854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59696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74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635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7564417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COLORECTAL_CANC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38937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.58866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73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4810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099112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RIBOSO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7192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3.1609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8012310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OXIDATIVE_PHOSPHORYL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9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997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656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736651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PARKINSONS_DISEAS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9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81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652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8162085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CARDIAC_MUSCLE_CONTRAC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5184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0877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0" i="0" u="none" strike="noStrike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59E-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444969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HUNTINGTONS_DISEAS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128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2.0004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CC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64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4531334"/>
                  </a:ext>
                </a:extLst>
              </a:tr>
              <a:tr h="145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KEGG_ALZHEIMERS_DISEAS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0.4118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-1.990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900" b="1" i="0" u="none" strike="noStrike" dirty="0">
                          <a:solidFill>
                            <a:srgbClr val="0000FF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00155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1691679"/>
                  </a:ext>
                </a:extLst>
              </a:tr>
            </a:tbl>
          </a:graphicData>
        </a:graphic>
      </p:graphicFrame>
      <p:sp>
        <p:nvSpPr>
          <p:cNvPr id="3" name="矩形 11">
            <a:extLst>
              <a:ext uri="{FF2B5EF4-FFF2-40B4-BE49-F238E27FC236}">
                <a16:creationId xmlns:a16="http://schemas.microsoft.com/office/drawing/2014/main" id="{551D9CAC-9C8E-AAFF-EFF1-8A56C3D34FCF}"/>
              </a:ext>
            </a:extLst>
          </p:cNvPr>
          <p:cNvSpPr/>
          <p:nvPr/>
        </p:nvSpPr>
        <p:spPr>
          <a:xfrm>
            <a:off x="263311" y="42730"/>
            <a:ext cx="584560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sz="1400" b="1" dirty="0">
                <a:solidFill>
                  <a:prstClr val="black"/>
                </a:solidFill>
                <a:latin typeface="Calibri" panose="020F0502020204030204"/>
                <a:ea typeface="新細明體" panose="02020500000000000000" pitchFamily="18" charset="-120"/>
              </a:rPr>
              <a:t>Pathways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enriched in Oxaliplatin-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resistant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or 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srgbClr val="0000CC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sensitive</a:t>
            </a:r>
            <a:r>
              <a:rPr kumimoji="0" lang="en-US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CRC PDOs</a:t>
            </a:r>
            <a:endParaRPr kumimoji="0" lang="zh-TW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89218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33</TotalTime>
  <Words>1659</Words>
  <Application>Microsoft Macintosh PowerPoint</Application>
  <PresentationFormat>Custom</PresentationFormat>
  <Paragraphs>8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musha valli</dc:creator>
  <cp:lastModifiedBy>khamusha valli</cp:lastModifiedBy>
  <cp:revision>82</cp:revision>
  <dcterms:created xsi:type="dcterms:W3CDTF">2021-04-14T03:01:17Z</dcterms:created>
  <dcterms:modified xsi:type="dcterms:W3CDTF">2022-05-30T08:23:28Z</dcterms:modified>
</cp:coreProperties>
</file>